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4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0" d="100"/>
          <a:sy n="90" d="100"/>
        </p:scale>
        <p:origin x="1162" y="82"/>
      </p:cViewPr>
      <p:guideLst>
        <p:guide orient="horz" pos="168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649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4567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537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4368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6074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9399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42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5893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0002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7224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96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A453D-3601-6F4F-942F-102C8B1A3B8A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52CAB-068A-6040-9984-E18125A7BD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74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7E9C11B5-D504-EFBD-72EB-AC4201A8E657}"/>
              </a:ext>
            </a:extLst>
          </p:cNvPr>
          <p:cNvGrpSpPr/>
          <p:nvPr/>
        </p:nvGrpSpPr>
        <p:grpSpPr>
          <a:xfrm>
            <a:off x="804672" y="543977"/>
            <a:ext cx="7354743" cy="3638401"/>
            <a:chOff x="804672" y="543977"/>
            <a:chExt cx="7354743" cy="3638401"/>
          </a:xfrm>
        </p:grpSpPr>
        <p:pic>
          <p:nvPicPr>
            <p:cNvPr id="2" name="図 1" descr="200522_β-actin(200515)-2.ti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672" y="543977"/>
              <a:ext cx="4972710" cy="3638401"/>
            </a:xfrm>
            <a:prstGeom prst="rect">
              <a:avLst/>
            </a:prstGeom>
          </p:spPr>
        </p:pic>
        <p:grpSp>
          <p:nvGrpSpPr>
            <p:cNvPr id="10" name="図形グループ 9"/>
            <p:cNvGrpSpPr/>
            <p:nvPr/>
          </p:nvGrpSpPr>
          <p:grpSpPr>
            <a:xfrm>
              <a:off x="5542108" y="2055140"/>
              <a:ext cx="2617307" cy="338554"/>
              <a:chOff x="5675930" y="3832020"/>
              <a:chExt cx="2617307" cy="338554"/>
            </a:xfrm>
          </p:grpSpPr>
          <p:sp>
            <p:nvSpPr>
              <p:cNvPr id="3" name="テキスト ボックス 2"/>
              <p:cNvSpPr txBox="1"/>
              <p:nvPr/>
            </p:nvSpPr>
            <p:spPr>
              <a:xfrm>
                <a:off x="6176507" y="3832020"/>
                <a:ext cx="21167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  <a:r>
                  <a:rPr kumimoji="1" lang="ja-JP" alt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β-actin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" name="直線矢印コネクタ 3"/>
              <p:cNvCxnSpPr/>
              <p:nvPr/>
            </p:nvCxnSpPr>
            <p:spPr>
              <a:xfrm flipH="1">
                <a:off x="5675930" y="4005165"/>
                <a:ext cx="478867" cy="0"/>
              </a:xfrm>
              <a:prstGeom prst="straightConnector1">
                <a:avLst/>
              </a:prstGeom>
              <a:ln w="28575" cmpd="sng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" name="図形グループ 4"/>
            <p:cNvGrpSpPr/>
            <p:nvPr/>
          </p:nvGrpSpPr>
          <p:grpSpPr>
            <a:xfrm>
              <a:off x="2692921" y="1854963"/>
              <a:ext cx="792000" cy="550440"/>
              <a:chOff x="3485768" y="643134"/>
              <a:chExt cx="875937" cy="550440"/>
            </a:xfrm>
          </p:grpSpPr>
          <p:cxnSp>
            <p:nvCxnSpPr>
              <p:cNvPr id="6" name="直線コネクタ 5"/>
              <p:cNvCxnSpPr/>
              <p:nvPr/>
            </p:nvCxnSpPr>
            <p:spPr>
              <a:xfrm>
                <a:off x="3496194" y="653574"/>
                <a:ext cx="0" cy="54000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直線コネクタ 6"/>
              <p:cNvCxnSpPr/>
              <p:nvPr/>
            </p:nvCxnSpPr>
            <p:spPr>
              <a:xfrm>
                <a:off x="4354169" y="643134"/>
                <a:ext cx="0" cy="54000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直線コネクタ 7"/>
              <p:cNvCxnSpPr/>
              <p:nvPr/>
            </p:nvCxnSpPr>
            <p:spPr>
              <a:xfrm flipV="1">
                <a:off x="3496193" y="651339"/>
                <a:ext cx="865512" cy="10856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線コネクタ 8"/>
              <p:cNvCxnSpPr/>
              <p:nvPr/>
            </p:nvCxnSpPr>
            <p:spPr>
              <a:xfrm flipV="1">
                <a:off x="3485768" y="1172843"/>
                <a:ext cx="865512" cy="10856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テキスト ボックス 11"/>
            <p:cNvSpPr txBox="1"/>
            <p:nvPr/>
          </p:nvSpPr>
          <p:spPr>
            <a:xfrm rot="19448725">
              <a:off x="1278034" y="2962118"/>
              <a:ext cx="13220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UVEC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 rot="19448725">
              <a:off x="1258420" y="3059187"/>
              <a:ext cx="18600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en-US" altLang="ja-JP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 rot="19448725">
              <a:off x="879032" y="3308036"/>
              <a:ext cx="27216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1 (5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 rot="19448725">
              <a:off x="1083737" y="3366605"/>
              <a:ext cx="29409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1 (10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 rot="19448725">
              <a:off x="1410387" y="3386345"/>
              <a:ext cx="299657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1 (20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 rot="19448725">
              <a:off x="2044549" y="3320054"/>
              <a:ext cx="27216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2 (5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 rot="19448725">
              <a:off x="2226531" y="3389441"/>
              <a:ext cx="29409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2 (10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 rot="19448725">
              <a:off x="2599825" y="3412643"/>
              <a:ext cx="299657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AR-2 siRNA-2 (20nM)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object 2">
            <a:extLst>
              <a:ext uri="{FF2B5EF4-FFF2-40B4-BE49-F238E27FC236}">
                <a16:creationId xmlns:a16="http://schemas.microsoft.com/office/drawing/2014/main" id="{F1B5D985-4FE5-4AEF-B3CC-C7ECC54AF8D7}"/>
              </a:ext>
            </a:extLst>
          </p:cNvPr>
          <p:cNvSpPr txBox="1"/>
          <p:nvPr/>
        </p:nvSpPr>
        <p:spPr>
          <a:xfrm>
            <a:off x="93141" y="28824"/>
            <a:ext cx="1445883" cy="3821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400" spc="-25" dirty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sz="2400" spc="-2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2400" spc="-20" dirty="0">
                <a:latin typeface="Arial" panose="020B0604020202020204" pitchFamily="34" charset="0"/>
                <a:cs typeface="Arial" panose="020B0604020202020204" pitchFamily="34" charset="0"/>
              </a:rPr>
              <a:t>ure S4</a:t>
            </a:r>
            <a:r>
              <a:rPr sz="2400" spc="-3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369728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39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ホワイト</vt:lpstr>
      <vt:lpstr>PowerPoint プレゼンテーション</vt:lpstr>
    </vt:vector>
  </TitlesOfParts>
  <Company>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 a</dc:creator>
  <cp:lastModifiedBy>佐久間　理吏</cp:lastModifiedBy>
  <cp:revision>17</cp:revision>
  <dcterms:created xsi:type="dcterms:W3CDTF">2022-08-22T02:01:34Z</dcterms:created>
  <dcterms:modified xsi:type="dcterms:W3CDTF">2023-03-15T03:37:21Z</dcterms:modified>
</cp:coreProperties>
</file>